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98" r:id="rId4"/>
    <p:sldId id="292" r:id="rId5"/>
    <p:sldId id="278" r:id="rId6"/>
    <p:sldId id="279" r:id="rId7"/>
    <p:sldId id="280" r:id="rId8"/>
    <p:sldId id="281" r:id="rId9"/>
    <p:sldId id="296" r:id="rId10"/>
    <p:sldId id="300" r:id="rId11"/>
    <p:sldId id="294" r:id="rId12"/>
    <p:sldId id="282" r:id="rId13"/>
    <p:sldId id="283" r:id="rId14"/>
    <p:sldId id="284" r:id="rId15"/>
    <p:sldId id="285" r:id="rId16"/>
    <p:sldId id="286" r:id="rId17"/>
    <p:sldId id="299" r:id="rId18"/>
    <p:sldId id="293" r:id="rId19"/>
    <p:sldId id="287" r:id="rId20"/>
    <p:sldId id="288" r:id="rId21"/>
    <p:sldId id="289" r:id="rId22"/>
    <p:sldId id="295" r:id="rId23"/>
    <p:sldId id="290" r:id="rId24"/>
    <p:sldId id="291" r:id="rId2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25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2843A0-2DFE-0998-BD1D-6731805701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CD4511-5C67-06D0-2ACB-42BC247317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AB561A-E635-EAA2-6FA7-1D96AF900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D0E838-37F9-1586-32CB-23B5B4EC0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711C2-ECD6-9828-8453-6A4B77294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885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E1749C-00DE-98A6-DA9A-0F8B1C99FC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4D007A-2F07-5652-670A-8FD703BEB0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B709E2-6D35-B2A1-B1B2-F78FFDCDA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0F0437-1B64-52BD-A318-2ADD3C6F7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94F305-3F05-3285-9FF2-EDB942A63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01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5D1B33B-26B1-DCC0-9407-15D34E5FF2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8BA547-F454-5C52-E6B3-24A698FF74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989B8A-F127-B7B9-3B58-DA58D8F47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C29F88-495A-C687-8621-27B2530F3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D4B01F-9CA8-3243-8DF4-D10E39F0A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427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DEADC-C4B4-CFB8-9B4F-C1770CFCA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F104B7-26A4-CAD3-B744-B305298DFB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12EFCB-983A-4D62-6E3F-B7A5856CD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958A7E-D939-DA85-43BA-1445F44DA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1470A0-FDF8-3325-8E5F-F187BB5DF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215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539DA9-BA41-65FB-6792-C4EF048DFD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A05CBE-9237-A8F0-6E13-F3EF857191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10226A-8DE0-D57D-24EC-D86208CC1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FE7752-E0A1-1F57-6E27-C48AFB12A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D4817A-CDD2-A226-C634-E7E2778A99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592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70110-7E2A-C9C6-C00D-DD038EC2C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54A16A-B989-EE90-BB0C-1C7F247905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94F06B-40B2-5267-BA6B-A552F627BB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7C894A-A8D3-2823-599F-5C1FA8CCB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EBE751-5D18-44D9-511D-D593E2281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32130E-1126-6939-AF58-BBFD3E6B0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342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9C6B6C-F46C-CEAE-9D2C-8DD8A986C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8757AD-C9CA-0FD7-26D5-F53BAEC032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4318E4-5C8D-7F2D-44A1-B590DBD787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01D817-D433-33CA-CF60-A6F587071D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BE32A2-F6AB-FE7E-B30B-212338187D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8E914F-DCAD-9D08-3E5D-A55B13272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FCC371-1371-4DC2-6408-C28B96B3F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A535FB0-2D4E-2F3A-D55B-71784FDF7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909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1F0245-E010-43BE-2BA3-FDDDA084DD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B966485-3378-352F-72B0-C2FEFE25D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9EC04E-3129-EB8B-CFFB-783973B5F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F50B5C-91E1-110A-E66C-DA7EE3F47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206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9B66C3-549D-D8FC-B0AA-C422DB4B1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642210-6C11-28CB-5589-3746E4BF9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959096-B4B6-56AF-5CBC-56B498F32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349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AF6AC1-2021-3BC8-86DB-61D314D85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084EFB-94AD-CFDC-C614-6193C2A488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E4B9DF-6700-4907-AFA3-C79B69E022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0736E9-B112-3082-3D9D-7EC43AC3C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B41A0D-791A-EB6D-88E9-497D97A62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1DC343-9A2F-A50A-1759-67ECD382C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37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0D6750-7121-25A0-67BB-F68190321D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FDD316-DE2F-E435-265B-AB885F4BC2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CDCA80-BEB2-67A1-EAE0-5C3D8190CE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4CEC41-2DB8-2F3B-1DED-F9C4953B8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8F1C6C-3D14-F15A-F45F-5A85D1A96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838B22-A03E-F30A-BCFE-6153089AF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48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EF4814-393D-27A3-9624-670BA1D4E8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F474E6-4368-BAAF-EFAF-FC6F7B7E3B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2FC552-08B3-988D-2457-3147698C8E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2C1656-955D-4D43-BC9D-739E55760FD5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82E625-429C-C84F-4F17-E4BACF62AC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84F2C-48A9-DE81-C386-43EAB554FF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52A859E-2B31-463B-959A-3D74F9A38A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274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0DE64E-BD28-7642-A85D-7CAF7D04B84A}"/>
              </a:ext>
            </a:extLst>
          </p:cNvPr>
          <p:cNvSpPr txBox="1">
            <a:spLocks/>
          </p:cNvSpPr>
          <p:nvPr/>
        </p:nvSpPr>
        <p:spPr>
          <a:xfrm>
            <a:off x="1063553" y="258785"/>
            <a:ext cx="10454640" cy="826656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</a:p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ugs docking human IL-6/IL-6R (1p9m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F63FC48-1238-5C01-70A0-1189A97014D8}"/>
              </a:ext>
            </a:extLst>
          </p:cNvPr>
          <p:cNvSpPr txBox="1"/>
          <p:nvPr/>
        </p:nvSpPr>
        <p:spPr>
          <a:xfrm>
            <a:off x="3137266" y="1299996"/>
            <a:ext cx="6583055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able S6 showing summary of drug docking human IL-6/IL-6R (1p9m)</a:t>
            </a:r>
          </a:p>
          <a:p>
            <a:r>
              <a:rPr lang="en-US" sz="16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via binding to critical residues for binding and glycosylation.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4A7DEE3-48A2-9883-26CB-09E14AAC87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8758820"/>
              </p:ext>
            </p:extLst>
          </p:nvPr>
        </p:nvGraphicFramePr>
        <p:xfrm>
          <a:off x="2828925" y="2008481"/>
          <a:ext cx="6534150" cy="40289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50010">
                  <a:extLst>
                    <a:ext uri="{9D8B030D-6E8A-4147-A177-3AD203B41FA5}">
                      <a16:colId xmlns:a16="http://schemas.microsoft.com/office/drawing/2014/main" val="4095776008"/>
                    </a:ext>
                  </a:extLst>
                </a:gridCol>
                <a:gridCol w="2592070">
                  <a:extLst>
                    <a:ext uri="{9D8B030D-6E8A-4147-A177-3AD203B41FA5}">
                      <a16:colId xmlns:a16="http://schemas.microsoft.com/office/drawing/2014/main" val="3962416331"/>
                    </a:ext>
                  </a:extLst>
                </a:gridCol>
                <a:gridCol w="2592070">
                  <a:extLst>
                    <a:ext uri="{9D8B030D-6E8A-4147-A177-3AD203B41FA5}">
                      <a16:colId xmlns:a16="http://schemas.microsoft.com/office/drawing/2014/main" val="1448017454"/>
                    </a:ext>
                  </a:extLst>
                </a:gridCol>
              </a:tblGrid>
              <a:tr h="5715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critical residues of IL-6 (chain B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critical residues of IL-6R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 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in (</a:t>
                      </a: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) and Beta chain (A) 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7637443"/>
                  </a:ext>
                </a:extLst>
              </a:tr>
              <a:tr h="16922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ymoquinone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g168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8125024"/>
                  </a:ext>
                </a:extLst>
              </a:tr>
              <a:tr h="10147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rtemisinin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ys50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11349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olsidomine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sn136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7076325"/>
                  </a:ext>
                </a:extLst>
              </a:tr>
              <a:tr h="17431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et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n135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5931205"/>
                  </a:ext>
                </a:extLst>
              </a:tr>
              <a:tr h="19231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desivir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7893011"/>
                  </a:ext>
                </a:extLst>
              </a:tr>
              <a:tr h="10147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minopterin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 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n224, Trp249, Arg259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7261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pigenin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20123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andesartan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sn224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3924330"/>
                  </a:ext>
                </a:extLst>
              </a:tr>
              <a:tr h="10147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indirubin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5778685"/>
                  </a:ext>
                </a:extLst>
              </a:tr>
              <a:tr h="202946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itazoxanide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0131703"/>
                  </a:ext>
                </a:extLst>
              </a:tr>
              <a:tr h="14790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alapril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5200186"/>
                  </a:ext>
                </a:extLst>
              </a:tr>
              <a:tr h="14790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xamethasone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n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60, Asn61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n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36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5996779"/>
                  </a:ext>
                </a:extLst>
              </a:tr>
              <a:tr h="3451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empferol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150, Cys160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112960"/>
                  </a:ext>
                </a:extLst>
              </a:tr>
              <a:tr h="33845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cetin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32268039"/>
                  </a:ext>
                </a:extLst>
              </a:tr>
              <a:tr h="33845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yptanthrin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940937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191863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F44561F-49BD-7ADB-E6BD-CBB69FEEED68}"/>
              </a:ext>
            </a:extLst>
          </p:cNvPr>
          <p:cNvSpPr/>
          <p:nvPr/>
        </p:nvSpPr>
        <p:spPr>
          <a:xfrm>
            <a:off x="651147" y="5789326"/>
            <a:ext cx="1063304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i: Dexamethason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close-up of a structure&#10;&#10;AI-generated content may be incorrect.">
            <a:extLst>
              <a:ext uri="{FF2B5EF4-FFF2-40B4-BE49-F238E27FC236}">
                <a16:creationId xmlns:a16="http://schemas.microsoft.com/office/drawing/2014/main" id="{BE00CE13-8346-65F0-69F4-9B9E670D62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937" y="483899"/>
            <a:ext cx="11144250" cy="5267325"/>
          </a:xfrm>
          <a:prstGeom prst="rect">
            <a:avLst/>
          </a:prstGeom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F61D2F6D-B32E-DA8D-23BA-F53606BB5F45}"/>
              </a:ext>
            </a:extLst>
          </p:cNvPr>
          <p:cNvSpPr/>
          <p:nvPr/>
        </p:nvSpPr>
        <p:spPr>
          <a:xfrm rot="15860144">
            <a:off x="9896737" y="4144023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E7365911-47C4-EF74-8082-FE04DEFC8DD1}"/>
              </a:ext>
            </a:extLst>
          </p:cNvPr>
          <p:cNvSpPr/>
          <p:nvPr/>
        </p:nvSpPr>
        <p:spPr>
          <a:xfrm rot="15891425">
            <a:off x="9158618" y="4359281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6707D90B-08C6-01D0-6AF5-0911E0C5A3E4}"/>
              </a:ext>
            </a:extLst>
          </p:cNvPr>
          <p:cNvSpPr/>
          <p:nvPr/>
        </p:nvSpPr>
        <p:spPr>
          <a:xfrm rot="15891425">
            <a:off x="8236197" y="4768355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1932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omputer screen&#10;&#10;AI-generated content may be incorrect.">
            <a:extLst>
              <a:ext uri="{FF2B5EF4-FFF2-40B4-BE49-F238E27FC236}">
                <a16:creationId xmlns:a16="http://schemas.microsoft.com/office/drawing/2014/main" id="{D1603489-043A-921D-5CA6-B4CDD304BB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965" y="774563"/>
            <a:ext cx="10116070" cy="530887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CEBCC7B-2467-C57D-77C4-1D612577E267}"/>
              </a:ext>
            </a:extLst>
          </p:cNvPr>
          <p:cNvSpPr/>
          <p:nvPr/>
        </p:nvSpPr>
        <p:spPr>
          <a:xfrm>
            <a:off x="1372593" y="6013915"/>
            <a:ext cx="9446818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j: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alapri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BCA93BF7-3D06-6ADA-AC2F-F48D6FA47D91}"/>
              </a:ext>
            </a:extLst>
          </p:cNvPr>
          <p:cNvSpPr/>
          <p:nvPr/>
        </p:nvSpPr>
        <p:spPr>
          <a:xfrm rot="4108080">
            <a:off x="8457921" y="663883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23531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76242DED-58C8-7E43-11E0-3699271D1106}"/>
              </a:ext>
            </a:extLst>
          </p:cNvPr>
          <p:cNvSpPr/>
          <p:nvPr/>
        </p:nvSpPr>
        <p:spPr>
          <a:xfrm>
            <a:off x="1486405" y="6141615"/>
            <a:ext cx="921919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k: Ferul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close-up of a diagram&#10;&#10;Description automatically generated">
            <a:extLst>
              <a:ext uri="{FF2B5EF4-FFF2-40B4-BE49-F238E27FC236}">
                <a16:creationId xmlns:a16="http://schemas.microsoft.com/office/drawing/2014/main" id="{C7E66503-6B14-D1DE-4B4A-A2566F9E28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439" y="568682"/>
            <a:ext cx="11079121" cy="5325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867664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656CC060-4D2A-4CF6-5B34-91074DEBD2D1}"/>
              </a:ext>
            </a:extLst>
          </p:cNvPr>
          <p:cNvSpPr/>
          <p:nvPr/>
        </p:nvSpPr>
        <p:spPr>
          <a:xfrm>
            <a:off x="1258778" y="6013915"/>
            <a:ext cx="967444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l: Indirub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close-up of a structure&#10;&#10;Description automatically generated">
            <a:extLst>
              <a:ext uri="{FF2B5EF4-FFF2-40B4-BE49-F238E27FC236}">
                <a16:creationId xmlns:a16="http://schemas.microsoft.com/office/drawing/2014/main" id="{1CF8DE39-A532-A098-F681-4DCCF8B67A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111" y="866775"/>
            <a:ext cx="11153775" cy="5124450"/>
          </a:xfrm>
          <a:prstGeom prst="rect">
            <a:avLst/>
          </a:prstGeom>
        </p:spPr>
      </p:pic>
      <p:sp>
        <p:nvSpPr>
          <p:cNvPr id="2" name="Arrow: Right 1">
            <a:extLst>
              <a:ext uri="{FF2B5EF4-FFF2-40B4-BE49-F238E27FC236}">
                <a16:creationId xmlns:a16="http://schemas.microsoft.com/office/drawing/2014/main" id="{589C8795-1A13-A30B-ABC8-A59BDAA20B36}"/>
              </a:ext>
            </a:extLst>
          </p:cNvPr>
          <p:cNvSpPr/>
          <p:nvPr/>
        </p:nvSpPr>
        <p:spPr>
          <a:xfrm rot="4108080">
            <a:off x="8772715" y="4411424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0684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84277EC-BDC4-F63B-2C73-43F5970FD2AC}"/>
              </a:ext>
            </a:extLst>
          </p:cNvPr>
          <p:cNvSpPr/>
          <p:nvPr/>
        </p:nvSpPr>
        <p:spPr>
          <a:xfrm>
            <a:off x="652684" y="6010285"/>
            <a:ext cx="1033648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m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oquinolo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close-up of a dna model&#10;&#10;Description automatically generated">
            <a:extLst>
              <a:ext uri="{FF2B5EF4-FFF2-40B4-BE49-F238E27FC236}">
                <a16:creationId xmlns:a16="http://schemas.microsoft.com/office/drawing/2014/main" id="{DD72B58D-3E4E-C10F-66F5-CF9CD2C3EE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751" y="571113"/>
            <a:ext cx="11182350" cy="5172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844196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8F1F274-8AE2-67FD-97E1-4636550E3C2D}"/>
              </a:ext>
            </a:extLst>
          </p:cNvPr>
          <p:cNvSpPr/>
          <p:nvPr/>
        </p:nvSpPr>
        <p:spPr>
          <a:xfrm>
            <a:off x="736555" y="6010285"/>
            <a:ext cx="1016874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n: Kaempfero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close-up of a structure&#10;&#10;Description automatically generated">
            <a:extLst>
              <a:ext uri="{FF2B5EF4-FFF2-40B4-BE49-F238E27FC236}">
                <a16:creationId xmlns:a16="http://schemas.microsoft.com/office/drawing/2014/main" id="{108A2DC3-0433-64F9-BF03-8C32A05EFC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154" y="694593"/>
            <a:ext cx="10631384" cy="5315692"/>
          </a:xfrm>
          <a:prstGeom prst="rect">
            <a:avLst/>
          </a:prstGeom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C6BB108C-6C74-0038-27DA-AC3CEC60502A}"/>
              </a:ext>
            </a:extLst>
          </p:cNvPr>
          <p:cNvSpPr/>
          <p:nvPr/>
        </p:nvSpPr>
        <p:spPr>
          <a:xfrm rot="5400000">
            <a:off x="9737562" y="1730215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84B4D035-CA2A-1FC2-6962-5696D23C89D2}"/>
              </a:ext>
            </a:extLst>
          </p:cNvPr>
          <p:cNvSpPr/>
          <p:nvPr/>
        </p:nvSpPr>
        <p:spPr>
          <a:xfrm rot="4108080">
            <a:off x="9321520" y="1956963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5971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BD8DCE5-FA7C-6429-AA85-6FF78EE4AD0E}"/>
              </a:ext>
            </a:extLst>
          </p:cNvPr>
          <p:cNvSpPr/>
          <p:nvPr/>
        </p:nvSpPr>
        <p:spPr>
          <a:xfrm>
            <a:off x="813609" y="6081712"/>
            <a:ext cx="1024511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o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 descr="A close-up of a structure&#10;&#10;Description automatically generated">
            <a:extLst>
              <a:ext uri="{FF2B5EF4-FFF2-40B4-BE49-F238E27FC236}">
                <a16:creationId xmlns:a16="http://schemas.microsoft.com/office/drawing/2014/main" id="{E35A130F-21C7-0212-6AB5-5C1A621024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637" y="781050"/>
            <a:ext cx="11134725" cy="5295900"/>
          </a:xfrm>
          <a:prstGeom prst="rect">
            <a:avLst/>
          </a:prstGeom>
        </p:spPr>
      </p:pic>
      <p:sp>
        <p:nvSpPr>
          <p:cNvPr id="3" name="Arrow: Right 2">
            <a:extLst>
              <a:ext uri="{FF2B5EF4-FFF2-40B4-BE49-F238E27FC236}">
                <a16:creationId xmlns:a16="http://schemas.microsoft.com/office/drawing/2014/main" id="{7D0A11F8-3FD7-E0BD-C66A-2F7FC0511F5D}"/>
              </a:ext>
            </a:extLst>
          </p:cNvPr>
          <p:cNvSpPr/>
          <p:nvPr/>
        </p:nvSpPr>
        <p:spPr>
          <a:xfrm rot="4621971">
            <a:off x="9712341" y="3078805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47038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iagram&#10;&#10;AI-generated content may be incorrect.">
            <a:extLst>
              <a:ext uri="{FF2B5EF4-FFF2-40B4-BE49-F238E27FC236}">
                <a16:creationId xmlns:a16="http://schemas.microsoft.com/office/drawing/2014/main" id="{F711689C-AE82-70CE-C3E0-56FF44B4F2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497" y="193638"/>
            <a:ext cx="10974332" cy="53156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C23CB11-6798-D394-DD1B-7F707CB33B29}"/>
              </a:ext>
            </a:extLst>
          </p:cNvPr>
          <p:cNvSpPr/>
          <p:nvPr/>
        </p:nvSpPr>
        <p:spPr>
          <a:xfrm>
            <a:off x="833888" y="5841080"/>
            <a:ext cx="1026755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p: Nitazoxanid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208A8372-6887-1C81-D2BC-089AF27E2102}"/>
              </a:ext>
            </a:extLst>
          </p:cNvPr>
          <p:cNvSpPr/>
          <p:nvPr/>
        </p:nvSpPr>
        <p:spPr>
          <a:xfrm rot="16043874">
            <a:off x="8594314" y="851541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02200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B8FC6F8-7ABF-8EC7-F7C5-D7EFE1FF0CA5}"/>
              </a:ext>
            </a:extLst>
          </p:cNvPr>
          <p:cNvSpPr/>
          <p:nvPr/>
        </p:nvSpPr>
        <p:spPr>
          <a:xfrm>
            <a:off x="1338594" y="6081712"/>
            <a:ext cx="919514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q: Phyt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close-up of a diagram&#10;&#10;Description automatically generated">
            <a:extLst>
              <a:ext uri="{FF2B5EF4-FFF2-40B4-BE49-F238E27FC236}">
                <a16:creationId xmlns:a16="http://schemas.microsoft.com/office/drawing/2014/main" id="{9FB36C49-1415-7DBB-E30D-FE33DFF526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421" y="780680"/>
            <a:ext cx="10669489" cy="5296639"/>
          </a:xfrm>
          <a:prstGeom prst="rect">
            <a:avLst/>
          </a:prstGeom>
        </p:spPr>
      </p:pic>
      <p:sp>
        <p:nvSpPr>
          <p:cNvPr id="2" name="Arrow: Right 1">
            <a:extLst>
              <a:ext uri="{FF2B5EF4-FFF2-40B4-BE49-F238E27FC236}">
                <a16:creationId xmlns:a16="http://schemas.microsoft.com/office/drawing/2014/main" id="{CB948813-8EB0-C642-38AC-0BF72F1F5D17}"/>
              </a:ext>
            </a:extLst>
          </p:cNvPr>
          <p:cNvSpPr/>
          <p:nvPr/>
        </p:nvSpPr>
        <p:spPr>
          <a:xfrm rot="16043874">
            <a:off x="10766015" y="2092511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88226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15D06BA-0F4A-1936-0258-AF95E2669B2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DF963F4-7A51-422E-000C-906826B629F8}"/>
              </a:ext>
            </a:extLst>
          </p:cNvPr>
          <p:cNvSpPr/>
          <p:nvPr/>
        </p:nvSpPr>
        <p:spPr>
          <a:xfrm>
            <a:off x="884036" y="6039782"/>
            <a:ext cx="987379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r: Quer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close-up of a dna model&#10;&#10;Description automatically generated">
            <a:extLst>
              <a:ext uri="{FF2B5EF4-FFF2-40B4-BE49-F238E27FC236}">
                <a16:creationId xmlns:a16="http://schemas.microsoft.com/office/drawing/2014/main" id="{AC95EDC1-0B69-29F7-59AE-CDFED8F029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387" y="775917"/>
            <a:ext cx="10755226" cy="5306165"/>
          </a:xfrm>
          <a:prstGeom prst="rect">
            <a:avLst/>
          </a:prstGeom>
        </p:spPr>
      </p:pic>
      <p:sp>
        <p:nvSpPr>
          <p:cNvPr id="6" name="Arrow: Right 5">
            <a:extLst>
              <a:ext uri="{FF2B5EF4-FFF2-40B4-BE49-F238E27FC236}">
                <a16:creationId xmlns:a16="http://schemas.microsoft.com/office/drawing/2014/main" id="{CAFCFBB3-8509-9B8E-46E2-8ED57B8A7B05}"/>
              </a:ext>
            </a:extLst>
          </p:cNvPr>
          <p:cNvSpPr/>
          <p:nvPr/>
        </p:nvSpPr>
        <p:spPr>
          <a:xfrm rot="4998936">
            <a:off x="7824541" y="1596278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41789A83-8DFC-E096-0477-A76684FFC4A9}"/>
              </a:ext>
            </a:extLst>
          </p:cNvPr>
          <p:cNvSpPr/>
          <p:nvPr/>
        </p:nvSpPr>
        <p:spPr>
          <a:xfrm rot="16043874">
            <a:off x="8702847" y="4303382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674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E55728C-628E-ED5E-F6D9-DD415F19300E}"/>
              </a:ext>
            </a:extLst>
          </p:cNvPr>
          <p:cNvSpPr/>
          <p:nvPr/>
        </p:nvSpPr>
        <p:spPr>
          <a:xfrm>
            <a:off x="1343739" y="6013915"/>
            <a:ext cx="950452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a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ca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1A4FCC89-CB3C-0B92-837C-992F1566A8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841" y="707750"/>
            <a:ext cx="10898121" cy="5306165"/>
          </a:xfrm>
          <a:prstGeom prst="rect">
            <a:avLst/>
          </a:prstGeom>
        </p:spPr>
      </p:pic>
      <p:sp>
        <p:nvSpPr>
          <p:cNvPr id="7" name="Arrow: Right 6">
            <a:extLst>
              <a:ext uri="{FF2B5EF4-FFF2-40B4-BE49-F238E27FC236}">
                <a16:creationId xmlns:a16="http://schemas.microsoft.com/office/drawing/2014/main" id="{5EE1A931-9DC3-85E5-E208-8975A779A537}"/>
              </a:ext>
            </a:extLst>
          </p:cNvPr>
          <p:cNvSpPr/>
          <p:nvPr/>
        </p:nvSpPr>
        <p:spPr>
          <a:xfrm rot="16043874">
            <a:off x="10243500" y="4509141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65585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FE66E6-C004-D85B-89F4-B3E8315CFF1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A44A5D9-140C-0DAB-2218-EC6813D7F33F}"/>
              </a:ext>
            </a:extLst>
          </p:cNvPr>
          <p:cNvSpPr/>
          <p:nvPr/>
        </p:nvSpPr>
        <p:spPr>
          <a:xfrm>
            <a:off x="983712" y="6039782"/>
            <a:ext cx="967444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Quinapri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close-up of a structure&#10;&#10;Description automatically generated">
            <a:extLst>
              <a:ext uri="{FF2B5EF4-FFF2-40B4-BE49-F238E27FC236}">
                <a16:creationId xmlns:a16="http://schemas.microsoft.com/office/drawing/2014/main" id="{8C8E4BFD-0281-D4D8-FD59-2D21EB79F5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775" y="833437"/>
            <a:ext cx="10458450" cy="5191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233106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74E5E2-9B65-14E2-234A-B19BD9D604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503CDD2-E63B-B062-F82F-3E23DC513639}"/>
              </a:ext>
            </a:extLst>
          </p:cNvPr>
          <p:cNvSpPr/>
          <p:nvPr/>
        </p:nvSpPr>
        <p:spPr>
          <a:xfrm>
            <a:off x="1016190" y="6013915"/>
            <a:ext cx="985718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t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Quisqualic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21BA4B95-5D67-7483-8D6F-A25FFB058F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801" y="707750"/>
            <a:ext cx="10659963" cy="5306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46304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AI-generated content may be incorrect.">
            <a:extLst>
              <a:ext uri="{FF2B5EF4-FFF2-40B4-BE49-F238E27FC236}">
                <a16:creationId xmlns:a16="http://schemas.microsoft.com/office/drawing/2014/main" id="{5B9B8384-9F25-342A-3C79-4F63DA6D8A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281" y="761628"/>
            <a:ext cx="10831437" cy="533474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CA72662-D3F4-6655-F7CC-0BB178F0B503}"/>
              </a:ext>
            </a:extLst>
          </p:cNvPr>
          <p:cNvSpPr/>
          <p:nvPr/>
        </p:nvSpPr>
        <p:spPr>
          <a:xfrm>
            <a:off x="973424" y="6013915"/>
            <a:ext cx="994272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u: Remdesivir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63E67D9F-5517-4610-C84B-6CF8ECD51289}"/>
              </a:ext>
            </a:extLst>
          </p:cNvPr>
          <p:cNvSpPr/>
          <p:nvPr/>
        </p:nvSpPr>
        <p:spPr>
          <a:xfrm rot="16043874">
            <a:off x="7030743" y="3854232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70320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0E1F59-1177-8574-2FED-5E2886F1E3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08BAA52-9209-E6A0-059D-65A3E81D382F}"/>
              </a:ext>
            </a:extLst>
          </p:cNvPr>
          <p:cNvSpPr/>
          <p:nvPr/>
        </p:nvSpPr>
        <p:spPr>
          <a:xfrm>
            <a:off x="783999" y="6013915"/>
            <a:ext cx="1062399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v: Thymoquinon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close-up of a dna model&#10;&#10;Description automatically generated">
            <a:extLst>
              <a:ext uri="{FF2B5EF4-FFF2-40B4-BE49-F238E27FC236}">
                <a16:creationId xmlns:a16="http://schemas.microsoft.com/office/drawing/2014/main" id="{4CB2D0A0-723D-96E6-A186-0FFF82E138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719" y="432305"/>
            <a:ext cx="10774279" cy="5334744"/>
          </a:xfrm>
          <a:prstGeom prst="rect">
            <a:avLst/>
          </a:prstGeom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F631D31E-4614-83AC-7955-44B9E58100AC}"/>
              </a:ext>
            </a:extLst>
          </p:cNvPr>
          <p:cNvSpPr/>
          <p:nvPr/>
        </p:nvSpPr>
        <p:spPr>
          <a:xfrm rot="4943222">
            <a:off x="10900434" y="3001697"/>
            <a:ext cx="197684" cy="19595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77663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AB0629-C616-C4F6-B44A-D98E57341C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BD92EC3-BDA8-983E-A733-1F7AF82EAB29}"/>
              </a:ext>
            </a:extLst>
          </p:cNvPr>
          <p:cNvSpPr/>
          <p:nvPr/>
        </p:nvSpPr>
        <p:spPr>
          <a:xfrm>
            <a:off x="981169" y="6013915"/>
            <a:ext cx="1022966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6x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A close-up of a computer screen&#10;&#10;Description automatically generated">
            <a:extLst>
              <a:ext uri="{FF2B5EF4-FFF2-40B4-BE49-F238E27FC236}">
                <a16:creationId xmlns:a16="http://schemas.microsoft.com/office/drawing/2014/main" id="{BAE5C790-7D4E-C353-DAA0-6FD0225C3D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938" y="688697"/>
            <a:ext cx="10898121" cy="5325218"/>
          </a:xfrm>
          <a:prstGeom prst="rect">
            <a:avLst/>
          </a:prstGeom>
        </p:spPr>
      </p:pic>
      <p:sp>
        <p:nvSpPr>
          <p:cNvPr id="8" name="Arrow: Right 7">
            <a:extLst>
              <a:ext uri="{FF2B5EF4-FFF2-40B4-BE49-F238E27FC236}">
                <a16:creationId xmlns:a16="http://schemas.microsoft.com/office/drawing/2014/main" id="{DCBD341C-DFD0-8369-1CAD-FC6E3216A7D4}"/>
              </a:ext>
            </a:extLst>
          </p:cNvPr>
          <p:cNvSpPr/>
          <p:nvPr/>
        </p:nvSpPr>
        <p:spPr>
          <a:xfrm rot="16043874">
            <a:off x="10384240" y="4261437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9B60621-33F0-839D-B1C3-4629DCA09066}"/>
              </a:ext>
            </a:extLst>
          </p:cNvPr>
          <p:cNvSpPr/>
          <p:nvPr/>
        </p:nvSpPr>
        <p:spPr>
          <a:xfrm rot="16043874">
            <a:off x="9211197" y="4467814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840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7BA27D1-FC6D-24F7-2E53-AE6380D5CF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1676" y="861654"/>
            <a:ext cx="11088647" cy="5134692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9DB14712-EB76-5FF4-942D-0F3CCE1C37D9}"/>
              </a:ext>
            </a:extLst>
          </p:cNvPr>
          <p:cNvSpPr/>
          <p:nvPr/>
        </p:nvSpPr>
        <p:spPr>
          <a:xfrm>
            <a:off x="991082" y="6013915"/>
            <a:ext cx="1020984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b: aminopter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72E11FC5-1FAA-1D66-48BC-1B9C524DBBD3}"/>
              </a:ext>
            </a:extLst>
          </p:cNvPr>
          <p:cNvSpPr/>
          <p:nvPr/>
        </p:nvSpPr>
        <p:spPr>
          <a:xfrm rot="5400000">
            <a:off x="6795964" y="2618557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D12422CC-B300-C92E-3312-96657A2B5807}"/>
              </a:ext>
            </a:extLst>
          </p:cNvPr>
          <p:cNvSpPr/>
          <p:nvPr/>
        </p:nvSpPr>
        <p:spPr>
          <a:xfrm rot="5400000">
            <a:off x="9617136" y="1764409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D814FC92-9373-776A-06F6-493EE4E8DA7B}"/>
              </a:ext>
            </a:extLst>
          </p:cNvPr>
          <p:cNvSpPr/>
          <p:nvPr/>
        </p:nvSpPr>
        <p:spPr>
          <a:xfrm rot="5400000">
            <a:off x="9184745" y="1764408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2477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2F930FF-D6B7-B322-C5A2-8DA8B0BA56FD}"/>
              </a:ext>
            </a:extLst>
          </p:cNvPr>
          <p:cNvSpPr/>
          <p:nvPr/>
        </p:nvSpPr>
        <p:spPr>
          <a:xfrm>
            <a:off x="1161798" y="6013915"/>
            <a:ext cx="986840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mygdal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 descr="A close-up of a dna structure&#10;&#10;Description automatically generated">
            <a:extLst>
              <a:ext uri="{FF2B5EF4-FFF2-40B4-BE49-F238E27FC236}">
                <a16:creationId xmlns:a16="http://schemas.microsoft.com/office/drawing/2014/main" id="{97F81206-EE5A-6FB1-567E-6A4BE279D1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439" y="259310"/>
            <a:ext cx="11079121" cy="5315692"/>
          </a:xfrm>
          <a:prstGeom prst="rect">
            <a:avLst/>
          </a:prstGeom>
        </p:spPr>
      </p:pic>
      <p:sp>
        <p:nvSpPr>
          <p:cNvPr id="2" name="Arrow: Right 1">
            <a:extLst>
              <a:ext uri="{FF2B5EF4-FFF2-40B4-BE49-F238E27FC236}">
                <a16:creationId xmlns:a16="http://schemas.microsoft.com/office/drawing/2014/main" id="{447CB8AC-4393-A63F-9511-A31D05FD67BD}"/>
              </a:ext>
            </a:extLst>
          </p:cNvPr>
          <p:cNvSpPr/>
          <p:nvPr/>
        </p:nvSpPr>
        <p:spPr>
          <a:xfrm rot="16043874">
            <a:off x="9024301" y="4401565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546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E80CBAA4-E945-CB5F-B212-7FA5853415F9}"/>
              </a:ext>
            </a:extLst>
          </p:cNvPr>
          <p:cNvSpPr/>
          <p:nvPr/>
        </p:nvSpPr>
        <p:spPr>
          <a:xfrm>
            <a:off x="1361371" y="6176211"/>
            <a:ext cx="946925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pigen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close-up of a diagram&#10;&#10;Description automatically generated">
            <a:extLst>
              <a:ext uri="{FF2B5EF4-FFF2-40B4-BE49-F238E27FC236}">
                <a16:creationId xmlns:a16="http://schemas.microsoft.com/office/drawing/2014/main" id="{D2AAAAFF-99C2-7564-7DF5-5960B85C68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0702" y="847725"/>
            <a:ext cx="10467975" cy="5162550"/>
          </a:xfrm>
          <a:prstGeom prst="rect">
            <a:avLst/>
          </a:prstGeom>
        </p:spPr>
      </p:pic>
      <p:sp>
        <p:nvSpPr>
          <p:cNvPr id="2" name="Arrow: Right 1">
            <a:extLst>
              <a:ext uri="{FF2B5EF4-FFF2-40B4-BE49-F238E27FC236}">
                <a16:creationId xmlns:a16="http://schemas.microsoft.com/office/drawing/2014/main" id="{4A8E4BC0-30C2-4B60-C083-ED4C8736CCCC}"/>
              </a:ext>
            </a:extLst>
          </p:cNvPr>
          <p:cNvSpPr/>
          <p:nvPr/>
        </p:nvSpPr>
        <p:spPr>
          <a:xfrm rot="5400000">
            <a:off x="7733382" y="799147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Arrow: Right 2">
            <a:extLst>
              <a:ext uri="{FF2B5EF4-FFF2-40B4-BE49-F238E27FC236}">
                <a16:creationId xmlns:a16="http://schemas.microsoft.com/office/drawing/2014/main" id="{3278EC00-B2CB-58FA-408B-9191CCAE5185}"/>
              </a:ext>
            </a:extLst>
          </p:cNvPr>
          <p:cNvSpPr/>
          <p:nvPr/>
        </p:nvSpPr>
        <p:spPr>
          <a:xfrm>
            <a:off x="6871629" y="4426267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0A4D7D70-C075-ECDB-758A-5F6BB13C4D5E}"/>
              </a:ext>
            </a:extLst>
          </p:cNvPr>
          <p:cNvSpPr/>
          <p:nvPr/>
        </p:nvSpPr>
        <p:spPr>
          <a:xfrm>
            <a:off x="7930204" y="4426266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2659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9A885552-7454-515B-CA39-33281C1101EB}"/>
              </a:ext>
            </a:extLst>
          </p:cNvPr>
          <p:cNvSpPr/>
          <p:nvPr/>
        </p:nvSpPr>
        <p:spPr>
          <a:xfrm>
            <a:off x="1051000" y="6163831"/>
            <a:ext cx="1009000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e: Artemisin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C4B41A9-62C5-211F-1731-83B82F7590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2229" y="635432"/>
            <a:ext cx="10507541" cy="5370440"/>
          </a:xfrm>
          <a:prstGeom prst="rect">
            <a:avLst/>
          </a:prstGeom>
        </p:spPr>
      </p:pic>
      <p:sp>
        <p:nvSpPr>
          <p:cNvPr id="7" name="Arrow: Right 6">
            <a:extLst>
              <a:ext uri="{FF2B5EF4-FFF2-40B4-BE49-F238E27FC236}">
                <a16:creationId xmlns:a16="http://schemas.microsoft.com/office/drawing/2014/main" id="{F7F1D5D8-4F72-E1D1-6B46-360F9DDBBEBB}"/>
              </a:ext>
            </a:extLst>
          </p:cNvPr>
          <p:cNvSpPr/>
          <p:nvPr/>
        </p:nvSpPr>
        <p:spPr>
          <a:xfrm rot="4621971">
            <a:off x="7846732" y="2360652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6508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735CD4FF-DC4F-69E2-99FD-FF0D7CDC6639}"/>
              </a:ext>
            </a:extLst>
          </p:cNvPr>
          <p:cNvSpPr/>
          <p:nvPr/>
        </p:nvSpPr>
        <p:spPr>
          <a:xfrm>
            <a:off x="1326907" y="6013915"/>
            <a:ext cx="9538188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f: Calcitrio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close-up of a structure&#10;&#10;Description automatically generated">
            <a:extLst>
              <a:ext uri="{FF2B5EF4-FFF2-40B4-BE49-F238E27FC236}">
                <a16:creationId xmlns:a16="http://schemas.microsoft.com/office/drawing/2014/main" id="{C45650D4-0A28-DCB0-6EF1-715F0E44CE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013" y="852487"/>
            <a:ext cx="10610850" cy="5153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38182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EBE557F3-3E88-25A3-0BBB-14DCB0AC4829}"/>
              </a:ext>
            </a:extLst>
          </p:cNvPr>
          <p:cNvSpPr/>
          <p:nvPr/>
        </p:nvSpPr>
        <p:spPr>
          <a:xfrm>
            <a:off x="1224315" y="6013915"/>
            <a:ext cx="974337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g: Coumar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close-up of a dna model&#10;&#10;Description automatically generated">
            <a:extLst>
              <a:ext uri="{FF2B5EF4-FFF2-40B4-BE49-F238E27FC236}">
                <a16:creationId xmlns:a16="http://schemas.microsoft.com/office/drawing/2014/main" id="{26BDF623-2A06-2EE2-E9F2-0135A84B2B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687" y="842962"/>
            <a:ext cx="11096625" cy="5172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3563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structure&#10;&#10;AI-generated content may be incorrect.">
            <a:extLst>
              <a:ext uri="{FF2B5EF4-FFF2-40B4-BE49-F238E27FC236}">
                <a16:creationId xmlns:a16="http://schemas.microsoft.com/office/drawing/2014/main" id="{046514A6-FF79-0173-C558-225D5D70D0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050" y="341027"/>
            <a:ext cx="11117226" cy="5277587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86B35BD-5545-CA31-352E-B02E0110F252}"/>
              </a:ext>
            </a:extLst>
          </p:cNvPr>
          <p:cNvSpPr/>
          <p:nvPr/>
        </p:nvSpPr>
        <p:spPr>
          <a:xfrm>
            <a:off x="902015" y="5789326"/>
            <a:ext cx="1013130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6h: Candesarta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6/IL-6R (1p9m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5559C3E0-0DD2-630F-C729-252D8B14D5B0}"/>
              </a:ext>
            </a:extLst>
          </p:cNvPr>
          <p:cNvSpPr/>
          <p:nvPr/>
        </p:nvSpPr>
        <p:spPr>
          <a:xfrm rot="7274421">
            <a:off x="11292401" y="3017166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743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2</TotalTime>
  <Words>401</Words>
  <Application>Microsoft Office PowerPoint</Application>
  <PresentationFormat>Widescreen</PresentationFormat>
  <Paragraphs>63</Paragraphs>
  <Slides>2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deer mohamed adel mahmoud elesseily</dc:creator>
  <cp:lastModifiedBy>Hadeer mohamed adel mahmoud elesseily</cp:lastModifiedBy>
  <cp:revision>38</cp:revision>
  <dcterms:created xsi:type="dcterms:W3CDTF">2025-01-07T09:49:39Z</dcterms:created>
  <dcterms:modified xsi:type="dcterms:W3CDTF">2025-09-17T21:23:28Z</dcterms:modified>
</cp:coreProperties>
</file>